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1" autoAdjust="0"/>
    <p:restoredTop sz="94660"/>
  </p:normalViewPr>
  <p:slideViewPr>
    <p:cSldViewPr snapToGrid="0">
      <p:cViewPr>
        <p:scale>
          <a:sx n="90" d="100"/>
          <a:sy n="90" d="100"/>
        </p:scale>
        <p:origin x="1104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FC97D-BA32-4705-8C29-B2907FD129F9}" type="datetimeFigureOut">
              <a:rPr lang="en-GB" smtClean="0"/>
              <a:t>07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C4C0-823B-4B7D-AE4E-A6655325B8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82197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FC97D-BA32-4705-8C29-B2907FD129F9}" type="datetimeFigureOut">
              <a:rPr lang="en-GB" smtClean="0"/>
              <a:t>07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C4C0-823B-4B7D-AE4E-A6655325B8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7541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FC97D-BA32-4705-8C29-B2907FD129F9}" type="datetimeFigureOut">
              <a:rPr lang="en-GB" smtClean="0"/>
              <a:t>07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C4C0-823B-4B7D-AE4E-A6655325B8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9953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FC97D-BA32-4705-8C29-B2907FD129F9}" type="datetimeFigureOut">
              <a:rPr lang="en-GB" smtClean="0"/>
              <a:t>07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C4C0-823B-4B7D-AE4E-A6655325B8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6794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FC97D-BA32-4705-8C29-B2907FD129F9}" type="datetimeFigureOut">
              <a:rPr lang="en-GB" smtClean="0"/>
              <a:t>07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C4C0-823B-4B7D-AE4E-A6655325B8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2667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FC97D-BA32-4705-8C29-B2907FD129F9}" type="datetimeFigureOut">
              <a:rPr lang="en-GB" smtClean="0"/>
              <a:t>07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C4C0-823B-4B7D-AE4E-A6655325B8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4214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FC97D-BA32-4705-8C29-B2907FD129F9}" type="datetimeFigureOut">
              <a:rPr lang="en-GB" smtClean="0"/>
              <a:t>07/06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C4C0-823B-4B7D-AE4E-A6655325B8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4029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FC97D-BA32-4705-8C29-B2907FD129F9}" type="datetimeFigureOut">
              <a:rPr lang="en-GB" smtClean="0"/>
              <a:t>07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C4C0-823B-4B7D-AE4E-A6655325B8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5124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FC97D-BA32-4705-8C29-B2907FD129F9}" type="datetimeFigureOut">
              <a:rPr lang="en-GB" smtClean="0"/>
              <a:t>07/06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C4C0-823B-4B7D-AE4E-A6655325B8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31985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FC97D-BA32-4705-8C29-B2907FD129F9}" type="datetimeFigureOut">
              <a:rPr lang="en-GB" smtClean="0"/>
              <a:t>07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C4C0-823B-4B7D-AE4E-A6655325B8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6287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FC97D-BA32-4705-8C29-B2907FD129F9}" type="datetimeFigureOut">
              <a:rPr lang="en-GB" smtClean="0"/>
              <a:t>07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C4C0-823B-4B7D-AE4E-A6655325B8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4266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EFC97D-BA32-4705-8C29-B2907FD129F9}" type="datetimeFigureOut">
              <a:rPr lang="en-GB" smtClean="0"/>
              <a:t>07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11C4C0-823B-4B7D-AE4E-A6655325B8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4023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7FDE6DB7-C3FA-4B55-9C99-49D14F60B7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1217342"/>
              </p:ext>
            </p:extLst>
          </p:nvPr>
        </p:nvGraphicFramePr>
        <p:xfrm>
          <a:off x="415291" y="524122"/>
          <a:ext cx="5953611" cy="498348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834018">
                  <a:extLst>
                    <a:ext uri="{9D8B030D-6E8A-4147-A177-3AD203B41FA5}">
                      <a16:colId xmlns:a16="http://schemas.microsoft.com/office/drawing/2014/main" val="3980938433"/>
                    </a:ext>
                  </a:extLst>
                </a:gridCol>
                <a:gridCol w="903834">
                  <a:extLst>
                    <a:ext uri="{9D8B030D-6E8A-4147-A177-3AD203B41FA5}">
                      <a16:colId xmlns:a16="http://schemas.microsoft.com/office/drawing/2014/main" val="3181634664"/>
                    </a:ext>
                  </a:extLst>
                </a:gridCol>
                <a:gridCol w="2355461">
                  <a:extLst>
                    <a:ext uri="{9D8B030D-6E8A-4147-A177-3AD203B41FA5}">
                      <a16:colId xmlns:a16="http://schemas.microsoft.com/office/drawing/2014/main" val="2702021014"/>
                    </a:ext>
                  </a:extLst>
                </a:gridCol>
                <a:gridCol w="1209358">
                  <a:extLst>
                    <a:ext uri="{9D8B030D-6E8A-4147-A177-3AD203B41FA5}">
                      <a16:colId xmlns:a16="http://schemas.microsoft.com/office/drawing/2014/main" val="1177654185"/>
                    </a:ext>
                  </a:extLst>
                </a:gridCol>
                <a:gridCol w="650940">
                  <a:extLst>
                    <a:ext uri="{9D8B030D-6E8A-4147-A177-3AD203B41FA5}">
                      <a16:colId xmlns:a16="http://schemas.microsoft.com/office/drawing/2014/main" val="2133443560"/>
                    </a:ext>
                  </a:extLst>
                </a:gridCol>
              </a:tblGrid>
              <a:tr h="32004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PQS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 err="1">
                          <a:effectLst/>
                        </a:rPr>
                        <a:t>Species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PQS </a:t>
                      </a:r>
                      <a:r>
                        <a:rPr lang="de-CH" sz="1100" kern="1200" dirty="0" err="1">
                          <a:effectLst/>
                        </a:rPr>
                        <a:t>sequence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Location (5' </a:t>
                      </a:r>
                      <a:r>
                        <a:rPr lang="de-CH" sz="1100" kern="1200" dirty="0" err="1">
                          <a:effectLst/>
                        </a:rPr>
                        <a:t>to</a:t>
                      </a:r>
                      <a:r>
                        <a:rPr lang="de-CH" sz="1100" kern="1200" dirty="0">
                          <a:effectLst/>
                        </a:rPr>
                        <a:t> 3')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G-Score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647560"/>
                  </a:ext>
                </a:extLst>
              </a:tr>
              <a:tr h="274320">
                <a:tc rowSpan="3">
                  <a:txBody>
                    <a:bodyPr/>
                    <a:lstStyle/>
                    <a:p>
                      <a:pPr algn="ctr">
                        <a:spcAft>
                          <a:spcPts val="500"/>
                        </a:spcAft>
                      </a:pPr>
                      <a:r>
                        <a:rPr lang="en-US" sz="1200" kern="1200" dirty="0">
                          <a:effectLst/>
                        </a:rPr>
                        <a:t>SMS</a:t>
                      </a:r>
                      <a:r>
                        <a:rPr lang="en-US" sz="1200" kern="1200" baseline="-25000" dirty="0">
                          <a:effectLst/>
                        </a:rPr>
                        <a:t>5Q1</a:t>
                      </a:r>
                      <a:endParaRPr lang="en-GB" sz="1200" dirty="0">
                        <a:effectLst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Human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CTGCTCCCCCA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CAT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CACA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71;13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16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22089929"/>
                  </a:ext>
                </a:extLst>
              </a:tr>
              <a:tr h="274320">
                <a:tc vMerge="1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Mouse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>
                          <a:effectLst/>
                        </a:rPr>
                        <a:t>GG</a:t>
                      </a:r>
                      <a:r>
                        <a:rPr lang="de-CH" sz="1000">
                          <a:effectLst/>
                        </a:rPr>
                        <a:t>TCGCCTCCCCA</a:t>
                      </a:r>
                      <a:r>
                        <a:rPr lang="de-CH" sz="1000" u="sng">
                          <a:effectLst/>
                        </a:rPr>
                        <a:t>GG</a:t>
                      </a:r>
                      <a:r>
                        <a:rPr lang="de-CH" sz="1000">
                          <a:effectLst/>
                        </a:rPr>
                        <a:t>CAT</a:t>
                      </a:r>
                      <a:r>
                        <a:rPr lang="de-CH" sz="1000" u="sng">
                          <a:effectLst/>
                        </a:rPr>
                        <a:t>GG</a:t>
                      </a:r>
                      <a:r>
                        <a:rPr lang="de-CH" sz="1000">
                          <a:effectLst/>
                        </a:rPr>
                        <a:t>CACA</a:t>
                      </a:r>
                      <a:r>
                        <a:rPr lang="de-CH" sz="1000" u="sng">
                          <a:effectLst/>
                        </a:rPr>
                        <a:t>G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295;13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16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6354605"/>
                  </a:ext>
                </a:extLst>
              </a:tr>
              <a:tr h="274320">
                <a:tc vMerge="1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ZebraFish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>
                          <a:effectLst/>
                        </a:rPr>
                        <a:t>GG</a:t>
                      </a:r>
                      <a:r>
                        <a:rPr lang="de-CH" sz="1000">
                          <a:effectLst/>
                        </a:rPr>
                        <a:t>CTGCCTCATCCA</a:t>
                      </a:r>
                      <a:r>
                        <a:rPr lang="de-CH" sz="1000" u="sng">
                          <a:effectLst/>
                        </a:rPr>
                        <a:t>GG</a:t>
                      </a:r>
                      <a:r>
                        <a:rPr lang="de-CH" sz="1000">
                          <a:effectLst/>
                        </a:rPr>
                        <a:t>CAT</a:t>
                      </a:r>
                      <a:r>
                        <a:rPr lang="de-CH" sz="1000" u="sng">
                          <a:effectLst/>
                        </a:rPr>
                        <a:t>GG</a:t>
                      </a:r>
                      <a:r>
                        <a:rPr lang="de-CH" sz="1000">
                          <a:effectLst/>
                        </a:rPr>
                        <a:t>CAGAC</a:t>
                      </a:r>
                      <a:r>
                        <a:rPr lang="de-CH" sz="1000" u="sng">
                          <a:effectLst/>
                        </a:rPr>
                        <a:t>GG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65;11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15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042035"/>
                  </a:ext>
                </a:extLst>
              </a:tr>
              <a:tr h="27432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200" dirty="0">
                          <a:effectLst/>
                        </a:rPr>
                        <a:t>SAT1</a:t>
                      </a:r>
                      <a:r>
                        <a:rPr lang="de-CH" sz="1200" baseline="-25000" dirty="0">
                          <a:effectLst/>
                        </a:rPr>
                        <a:t>5Q1</a:t>
                      </a:r>
                      <a:endParaRPr lang="en-GB" sz="1200" dirty="0">
                        <a:effectLst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Human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 kern="1200" dirty="0">
                          <a:effectLst/>
                        </a:rPr>
                        <a:t>GGGG</a:t>
                      </a:r>
                      <a:r>
                        <a:rPr lang="de-CH" sz="1000" kern="1200" dirty="0">
                          <a:effectLst/>
                        </a:rPr>
                        <a:t>CCT</a:t>
                      </a: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r>
                        <a:rPr lang="de-CH" sz="1000" kern="1200" dirty="0">
                          <a:effectLst/>
                        </a:rPr>
                        <a:t>TCCGCAAA</a:t>
                      </a: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139;21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16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2947607"/>
                  </a:ext>
                </a:extLst>
              </a:tr>
              <a:tr h="274320">
                <a:tc vMerge="1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Mouse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 dirty="0">
                          <a:effectLst/>
                        </a:rPr>
                        <a:t>GGGG</a:t>
                      </a:r>
                      <a:r>
                        <a:rPr lang="de-CH" sz="1000" dirty="0">
                          <a:effectLst/>
                        </a:rPr>
                        <a:t>CCT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TCCGCAAA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241;21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16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4580786"/>
                  </a:ext>
                </a:extLst>
              </a:tr>
              <a:tr h="27432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200" kern="1200" dirty="0">
                          <a:effectLst/>
                        </a:rPr>
                        <a:t>AZIN1</a:t>
                      </a:r>
                      <a:r>
                        <a:rPr lang="de-CH" sz="1200" kern="1200" baseline="-25000" dirty="0">
                          <a:effectLst/>
                        </a:rPr>
                        <a:t>5Q1</a:t>
                      </a:r>
                      <a:endParaRPr lang="en-GB" sz="1200" dirty="0">
                        <a:effectLst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Human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ACCCAGACATA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CTT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T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688;55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14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4853025"/>
                  </a:ext>
                </a:extLst>
              </a:tr>
              <a:tr h="274320">
                <a:tc vMerge="1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Mouse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ACCCAGACATA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CTT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T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512;55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14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9847420"/>
                  </a:ext>
                </a:extLst>
              </a:tr>
              <a:tr h="27432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200" kern="1200" dirty="0">
                          <a:effectLst/>
                        </a:rPr>
                        <a:t>SMS</a:t>
                      </a:r>
                      <a:r>
                        <a:rPr lang="de-CH" sz="1200" kern="1200" baseline="-25000" dirty="0">
                          <a:effectLst/>
                        </a:rPr>
                        <a:t>3Q1</a:t>
                      </a:r>
                      <a:endParaRPr lang="en-GB" sz="1200" dirty="0">
                        <a:effectLst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Human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r>
                        <a:rPr lang="de-CH" sz="1000" kern="1200" dirty="0">
                          <a:effectLst/>
                        </a:rPr>
                        <a:t>TAGATCTTCAATTT</a:t>
                      </a: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r>
                        <a:rPr lang="de-CH" sz="1000" kern="1200" dirty="0">
                          <a:effectLst/>
                        </a:rPr>
                        <a:t>ATATTT</a:t>
                      </a: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r>
                        <a:rPr lang="de-CH" sz="1000" kern="1200" dirty="0">
                          <a:effectLst/>
                        </a:rPr>
                        <a:t>A</a:t>
                      </a: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315;140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8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8395377"/>
                  </a:ext>
                </a:extLst>
              </a:tr>
              <a:tr h="274320">
                <a:tc vMerge="1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Gorilla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TAGATCTTCAATTT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ATATTT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A</a:t>
                      </a:r>
                      <a:r>
                        <a:rPr lang="de-CH" sz="1000" u="sng" dirty="0">
                          <a:effectLst/>
                        </a:rPr>
                        <a:t>G</a:t>
                      </a:r>
                      <a:r>
                        <a:rPr lang="de-CH" sz="1000" dirty="0">
                          <a:effectLst/>
                        </a:rPr>
                        <a:t>G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442;0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8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9081514"/>
                  </a:ext>
                </a:extLst>
              </a:tr>
              <a:tr h="27432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200" kern="1200" dirty="0">
                          <a:effectLst/>
                        </a:rPr>
                        <a:t>ARG2</a:t>
                      </a:r>
                      <a:r>
                        <a:rPr lang="de-CH" sz="1200" kern="1200" baseline="-25000" dirty="0">
                          <a:effectLst/>
                        </a:rPr>
                        <a:t>3Q1</a:t>
                      </a:r>
                      <a:endParaRPr lang="en-GB" sz="1200" dirty="0">
                        <a:effectLst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Human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r>
                        <a:rPr lang="de-CH" sz="1000" kern="1200" dirty="0">
                          <a:effectLst/>
                        </a:rPr>
                        <a:t>CATTCCAGAATTATGA</a:t>
                      </a: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r>
                        <a:rPr lang="de-CH" sz="1000" kern="1200" dirty="0">
                          <a:effectLst/>
                        </a:rPr>
                        <a:t>CATTGA</a:t>
                      </a:r>
                      <a:r>
                        <a:rPr lang="de-CH" sz="1000" u="sng" kern="1200" dirty="0">
                          <a:effectLst/>
                        </a:rPr>
                        <a:t>GGGG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31;739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5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9681611"/>
                  </a:ext>
                </a:extLst>
              </a:tr>
              <a:tr h="274320">
                <a:tc vMerge="1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Gorilla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r>
                        <a:rPr lang="de-CH" sz="1000" kern="1200" dirty="0">
                          <a:effectLst/>
                        </a:rPr>
                        <a:t>CATTCCAGAATTATGA</a:t>
                      </a: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r>
                        <a:rPr lang="de-CH" sz="1000" kern="1200" dirty="0">
                          <a:effectLst/>
                        </a:rPr>
                        <a:t>CATTGA</a:t>
                      </a:r>
                      <a:r>
                        <a:rPr lang="de-CH" sz="1000" u="sng" kern="1200" dirty="0">
                          <a:effectLst/>
                        </a:rPr>
                        <a:t>GGGG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31; 736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5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0497820"/>
                  </a:ext>
                </a:extLst>
              </a:tr>
              <a:tr h="27432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200" kern="1200" dirty="0">
                          <a:effectLst/>
                        </a:rPr>
                        <a:t>OAZ3</a:t>
                      </a:r>
                      <a:r>
                        <a:rPr lang="de-CH" sz="1200" kern="1200" baseline="-25000" dirty="0">
                          <a:effectLst/>
                        </a:rPr>
                        <a:t>3Q1</a:t>
                      </a:r>
                      <a:endParaRPr lang="en-GB" sz="1200" dirty="0">
                        <a:effectLst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Human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AATCA</a:t>
                      </a:r>
                      <a:r>
                        <a:rPr lang="de-CH" sz="1000" u="sng" dirty="0">
                          <a:effectLst/>
                        </a:rPr>
                        <a:t>GGGG</a:t>
                      </a:r>
                      <a:r>
                        <a:rPr lang="de-CH" sz="1000" dirty="0">
                          <a:effectLst/>
                        </a:rPr>
                        <a:t>CCC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45:66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18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8972004"/>
                  </a:ext>
                </a:extLst>
              </a:tr>
              <a:tr h="274320">
                <a:tc vMerge="1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Chimpanzee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AATCA</a:t>
                      </a:r>
                      <a:r>
                        <a:rPr lang="de-CH" sz="1000" u="sng" dirty="0">
                          <a:effectLst/>
                        </a:rPr>
                        <a:t>GGGG</a:t>
                      </a:r>
                      <a:r>
                        <a:rPr lang="de-CH" sz="1000" dirty="0">
                          <a:effectLst/>
                        </a:rPr>
                        <a:t>CCT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45:66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18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7683950"/>
                  </a:ext>
                </a:extLst>
              </a:tr>
              <a:tr h="27432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200" kern="1200" dirty="0">
                          <a:effectLst/>
                        </a:rPr>
                        <a:t>ODC1</a:t>
                      </a:r>
                      <a:r>
                        <a:rPr lang="de-CH" sz="1200" kern="1200" baseline="-25000" dirty="0">
                          <a:effectLst/>
                        </a:rPr>
                        <a:t>5Q2</a:t>
                      </a:r>
                      <a:endParaRPr lang="en-GB" sz="1200" dirty="0">
                        <a:effectLst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Human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r>
                        <a:rPr lang="de-CH" sz="1000" kern="1200" dirty="0">
                          <a:effectLst/>
                        </a:rPr>
                        <a:t>C</a:t>
                      </a: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r>
                        <a:rPr lang="de-CH" sz="1000" kern="1200" dirty="0">
                          <a:effectLst/>
                        </a:rPr>
                        <a:t>G</a:t>
                      </a: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r>
                        <a:rPr lang="de-CH" sz="1000" kern="1200" dirty="0">
                          <a:effectLst/>
                        </a:rPr>
                        <a:t>C</a:t>
                      </a: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r>
                        <a:rPr lang="de-CH" sz="1000" u="sng" dirty="0">
                          <a:effectLst/>
                        </a:rPr>
                        <a:t> 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290;210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21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8596113"/>
                  </a:ext>
                </a:extLst>
              </a:tr>
              <a:tr h="274320">
                <a:tc vMerge="1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Mouse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r>
                        <a:rPr lang="de-CH" sz="1000" kern="1200" dirty="0">
                          <a:effectLst/>
                        </a:rPr>
                        <a:t>C</a:t>
                      </a: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r>
                        <a:rPr lang="de-CH" sz="1000" kern="1200" dirty="0">
                          <a:effectLst/>
                        </a:rPr>
                        <a:t>C</a:t>
                      </a: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r>
                        <a:rPr lang="de-CH" sz="1000" kern="1200" dirty="0">
                          <a:effectLst/>
                        </a:rPr>
                        <a:t>C</a:t>
                      </a:r>
                      <a:r>
                        <a:rPr lang="de-CH" sz="1000" u="sng" kern="1200" dirty="0">
                          <a:effectLst/>
                        </a:rPr>
                        <a:t>GG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276;199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21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5940516"/>
                  </a:ext>
                </a:extLst>
              </a:tr>
              <a:tr h="27432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200" kern="1200" dirty="0">
                          <a:effectLst/>
                        </a:rPr>
                        <a:t>ODC1</a:t>
                      </a:r>
                      <a:r>
                        <a:rPr lang="de-CH" sz="1200" kern="1200" baseline="-25000" dirty="0">
                          <a:effectLst/>
                        </a:rPr>
                        <a:t>5Q3</a:t>
                      </a:r>
                      <a:endParaRPr lang="en-GB" sz="1200" dirty="0">
                        <a:effectLst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 dirty="0">
                          <a:effectLst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Human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GGCT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CCTGC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CGCCT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200">
                          <a:effectLst/>
                        </a:rPr>
                        <a:t>352;137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20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1258028"/>
                  </a:ext>
                </a:extLst>
              </a:tr>
              <a:tr h="274320">
                <a:tc vMerge="1"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de-CH" sz="1100" kern="1200">
                          <a:effectLst/>
                        </a:rPr>
                        <a:t>Gorilla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GACT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ACTGC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r>
                        <a:rPr lang="de-CH" sz="1000" dirty="0">
                          <a:effectLst/>
                        </a:rPr>
                        <a:t>CGTCT</a:t>
                      </a:r>
                      <a:r>
                        <a:rPr lang="de-CH" sz="1000" u="sng" dirty="0">
                          <a:effectLst/>
                        </a:rPr>
                        <a:t>GG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>
                          <a:effectLst/>
                        </a:rPr>
                        <a:t>258;137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CH" sz="1100" dirty="0">
                          <a:effectLst/>
                        </a:rPr>
                        <a:t>20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0937867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67FC8B31-189C-4188-AFBB-0E440346C17F}"/>
              </a:ext>
            </a:extLst>
          </p:cNvPr>
          <p:cNvSpPr txBox="1"/>
          <p:nvPr/>
        </p:nvSpPr>
        <p:spPr>
          <a:xfrm>
            <a:off x="0" y="0"/>
            <a:ext cx="13269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2 Source data 1</a:t>
            </a:r>
          </a:p>
        </p:txBody>
      </p:sp>
    </p:spTree>
    <p:extLst>
      <p:ext uri="{BB962C8B-B14F-4D97-AF65-F5344CB8AC3E}">
        <p14:creationId xmlns:p14="http://schemas.microsoft.com/office/powerpoint/2010/main" val="24250838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1</TotalTime>
  <Words>94</Words>
  <Application>Microsoft Office PowerPoint</Application>
  <PresentationFormat>Widescreen</PresentationFormat>
  <Paragraphs>9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ghtfoot, Helen</dc:creator>
  <cp:lastModifiedBy>Lightfoot, Helen</cp:lastModifiedBy>
  <cp:revision>5</cp:revision>
  <dcterms:created xsi:type="dcterms:W3CDTF">2018-06-05T19:08:21Z</dcterms:created>
  <dcterms:modified xsi:type="dcterms:W3CDTF">2018-06-07T13:57:10Z</dcterms:modified>
</cp:coreProperties>
</file>